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88BD7-EAC2-4E4E-AACC-FC2273937A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13C7C-3416-4ABC-9674-94D645E58E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2F873-A17E-48B1-9650-5CF4EB4022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BD952-954E-423C-B09E-764FEC5848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ED975-EA8A-458D-B9AA-1AB82993A4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F4C77-0A73-4BB3-B226-0BFDDAD60C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77E4D-C4B9-40D7-A0A6-08D41334CE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8C6B8-A5B4-4AAD-9F11-62AAC56C8A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149B1-E7D5-4DBF-B51D-00124E5752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E45EB-76A5-46E3-8653-2068781904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92B29-9FDA-4941-BC13-6DBC9B9BC7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9C0DB-2BF3-48F5-98F5-F2E581DC4C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82F3F8-DE33-4B9B-9E5C-039E97FC725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0" y="7323120"/>
            <a:ext cx="6858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Phylogenetic relationships among STB03, BTS02, and 30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chinochlo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ccessions based on the nucleotide sequences of trnT-L-F region of the chloroplast genome. The tree was constructed using the ML method. Bootstrap values with less than 50 are not show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971640" y="609480"/>
            <a:ext cx="4913280" cy="606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04:17:23Z</dcterms:created>
  <dc:creator>Chuyu YE</dc:creator>
  <dc:description/>
  <dc:language>en-US</dc:language>
  <cp:lastModifiedBy>user</cp:lastModifiedBy>
  <dcterms:modified xsi:type="dcterms:W3CDTF">2014-11-01T04:18:30Z</dcterms:modified>
  <cp:revision>3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